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6303" autoAdjust="0"/>
  </p:normalViewPr>
  <p:slideViewPr>
    <p:cSldViewPr snapToGrid="0">
      <p:cViewPr varScale="1">
        <p:scale>
          <a:sx n="164" d="100"/>
          <a:sy n="164" d="100"/>
        </p:scale>
        <p:origin x="-57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729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863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216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296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61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970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26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801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022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982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814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5F1EB-0F5B-FB40-AAD7-92B8CBB9973D}" type="datetimeFigureOut">
              <a:rPr lang="en-US" smtClean="0"/>
              <a:t>9/1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96451F-38F9-9F41-9817-99F2ABCB19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090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1193" y="852657"/>
            <a:ext cx="40436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smtClean="0">
                <a:latin typeface="Arial"/>
                <a:cs typeface="Arial"/>
              </a:rPr>
              <a:t>Table S2</a:t>
            </a:r>
            <a:endParaRPr lang="en-US" sz="2000" b="1" dirty="0">
              <a:latin typeface="Arial"/>
              <a:cs typeface="Arial"/>
            </a:endParaRP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4779542"/>
              </p:ext>
            </p:extLst>
          </p:nvPr>
        </p:nvGraphicFramePr>
        <p:xfrm>
          <a:off x="457200" y="1828800"/>
          <a:ext cx="8153398" cy="2849880"/>
        </p:xfrm>
        <a:graphic>
          <a:graphicData uri="http://schemas.openxmlformats.org/drawingml/2006/table">
            <a:tbl>
              <a:tblPr/>
              <a:tblGrid>
                <a:gridCol w="1752600"/>
                <a:gridCol w="914400"/>
                <a:gridCol w="762000"/>
                <a:gridCol w="762000"/>
                <a:gridCol w="990600"/>
                <a:gridCol w="76200"/>
                <a:gridCol w="1163002"/>
                <a:gridCol w="789860"/>
                <a:gridCol w="942736"/>
              </a:tblGrid>
              <a:tr h="175260">
                <a:tc>
                  <a:txBody>
                    <a:bodyPr/>
                    <a:lstStyle/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redicted miRNA</a:t>
                      </a:r>
                    </a:p>
                    <a:p>
                      <a:pPr marL="0" marR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L-6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RN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Expression level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NT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D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old 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NT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D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old chang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hsa-miR-140-3p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Low</a:t>
                      </a:r>
                      <a:endParaRPr lang="en-US" sz="12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86.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48.2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12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82.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90.1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.80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hsa-miR-41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69.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94.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.14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84.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10.1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08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30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1.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1.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.38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9.2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9.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52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381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0.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8.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26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0.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8.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56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136-3p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4.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0.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09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3.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94.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28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129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.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.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83.41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.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.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,511.212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202-3p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.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.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.24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.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.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.902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44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.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.2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75.92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.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.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50.71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146a-3p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.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5.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,101.46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.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.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05.632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146b-3p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.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.34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.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.89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21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.1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.1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40.75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.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.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06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340-3p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.1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8.1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.63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2.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7.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.421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hsa-miR-26b-3p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ery</a:t>
                      </a:r>
                      <a:r>
                        <a:rPr lang="en-US" sz="1200" b="0" i="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Low</a:t>
                      </a:r>
                      <a:endParaRPr lang="en-US" sz="1200" b="0" i="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.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0.2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,934.99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.3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4.7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3.64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cxnSp>
        <p:nvCxnSpPr>
          <p:cNvPr id="15" name="Straight Connector 14"/>
          <p:cNvCxnSpPr/>
          <p:nvPr/>
        </p:nvCxnSpPr>
        <p:spPr>
          <a:xfrm flipV="1">
            <a:off x="3102794" y="1758601"/>
            <a:ext cx="2530963" cy="2862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5709868" y="1747745"/>
            <a:ext cx="2887310" cy="12594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102794" y="1383179"/>
            <a:ext cx="25526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/>
                <a:cs typeface="Arial"/>
              </a:rPr>
              <a:t>TLR6</a:t>
            </a:r>
            <a:r>
              <a:rPr lang="en-US" sz="1600" b="1" baseline="30000" dirty="0" smtClean="0">
                <a:latin typeface="Arial"/>
                <a:cs typeface="Arial"/>
              </a:rPr>
              <a:t>-</a:t>
            </a:r>
            <a:endParaRPr lang="en-US" sz="1600" b="1" baseline="300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721833" y="1404889"/>
            <a:ext cx="2886200" cy="350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/>
                <a:cs typeface="Arial"/>
              </a:rPr>
              <a:t>TLR6</a:t>
            </a:r>
            <a:r>
              <a:rPr lang="en-US" sz="1600" b="1" baseline="30000" dirty="0" smtClean="0">
                <a:latin typeface="Arial"/>
                <a:cs typeface="Arial"/>
              </a:rPr>
              <a:t>+</a:t>
            </a:r>
            <a:endParaRPr lang="en-US" sz="1600" b="1" baseline="30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88458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04</Words>
  <Application>Microsoft Macintosh PowerPoint</Application>
  <PresentationFormat>On-screen Show (4:3)</PresentationFormat>
  <Paragraphs>1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Yal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kki Abrahams</dc:creator>
  <cp:lastModifiedBy>Vikki Abrahams</cp:lastModifiedBy>
  <cp:revision>15</cp:revision>
  <dcterms:created xsi:type="dcterms:W3CDTF">2013-04-05T16:56:52Z</dcterms:created>
  <dcterms:modified xsi:type="dcterms:W3CDTF">2013-09-11T15:48:40Z</dcterms:modified>
</cp:coreProperties>
</file>